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45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69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8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575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029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35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898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76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623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187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457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022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2B1C0-24B7-4C6B-A8EC-4E6A143CDAF7}" type="datetimeFigureOut">
              <a:rPr lang="en-US" smtClean="0"/>
              <a:t>6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9FB98-4E08-4573-B038-1096A21F74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450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05199" y="1189506"/>
            <a:ext cx="4588478" cy="416547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582562" y="5461686"/>
            <a:ext cx="622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A</a:t>
            </a:r>
          </a:p>
        </p:txBody>
      </p:sp>
    </p:spTree>
    <p:extLst>
      <p:ext uri="{BB962C8B-B14F-4D97-AF65-F5344CB8AC3E}">
        <p14:creationId xmlns:p14="http://schemas.microsoft.com/office/powerpoint/2010/main" val="468005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66985" y="1286166"/>
            <a:ext cx="4390766" cy="40710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82562" y="5461686"/>
            <a:ext cx="622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B</a:t>
            </a:r>
          </a:p>
        </p:txBody>
      </p:sp>
    </p:spTree>
    <p:extLst>
      <p:ext uri="{BB962C8B-B14F-4D97-AF65-F5344CB8AC3E}">
        <p14:creationId xmlns:p14="http://schemas.microsoft.com/office/powerpoint/2010/main" val="1077947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66984" y="1373508"/>
            <a:ext cx="4588476" cy="42176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82562" y="5696464"/>
            <a:ext cx="622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2A</a:t>
            </a:r>
          </a:p>
        </p:txBody>
      </p:sp>
    </p:spTree>
    <p:extLst>
      <p:ext uri="{BB962C8B-B14F-4D97-AF65-F5344CB8AC3E}">
        <p14:creationId xmlns:p14="http://schemas.microsoft.com/office/powerpoint/2010/main" val="33200896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061254" y="1213756"/>
            <a:ext cx="4316628" cy="396869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82562" y="5461686"/>
            <a:ext cx="622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2B</a:t>
            </a:r>
          </a:p>
        </p:txBody>
      </p:sp>
    </p:spTree>
    <p:extLst>
      <p:ext uri="{BB962C8B-B14F-4D97-AF65-F5344CB8AC3E}">
        <p14:creationId xmlns:p14="http://schemas.microsoft.com/office/powerpoint/2010/main" val="3685802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12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my S</dc:creator>
  <cp:lastModifiedBy>Tommy S</cp:lastModifiedBy>
  <cp:revision>5</cp:revision>
  <dcterms:created xsi:type="dcterms:W3CDTF">2016-06-21T20:56:54Z</dcterms:created>
  <dcterms:modified xsi:type="dcterms:W3CDTF">2016-06-21T22:47:03Z</dcterms:modified>
</cp:coreProperties>
</file>